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173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34343"/>
    <a:srgbClr val="393939"/>
    <a:srgbClr val="4D4D4D"/>
    <a:srgbClr val="454545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230"/>
    <p:restoredTop sz="95510"/>
  </p:normalViewPr>
  <p:slideViewPr>
    <p:cSldViewPr snapToGrid="0">
      <p:cViewPr>
        <p:scale>
          <a:sx n="400" d="100"/>
          <a:sy n="400" d="100"/>
        </p:scale>
        <p:origin x="30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0577C9-7F0F-2F44-91C9-3A995B29DEEE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A87E26-EF96-AB4C-8047-13E4C86D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0770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A87E26-EF96-AB4C-8047-13E4C86D60F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73811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10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00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954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1818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965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774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5488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0278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7686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506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1193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AD5C57-7226-E648-9E43-A49C4886F094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51286A-68CE-CC4B-9762-ABE2878348C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794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jpeg"/><Relationship Id="rId7" Type="http://schemas.openxmlformats.org/officeDocument/2006/relationships/image" Target="../media/image5.tiff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png"/><Relationship Id="rId5" Type="http://schemas.openxmlformats.org/officeDocument/2006/relationships/image" Target="../media/image3.tiff"/><Relationship Id="rId10" Type="http://schemas.openxmlformats.org/officeDocument/2006/relationships/image" Target="../media/image8.png"/><Relationship Id="rId4" Type="http://schemas.openxmlformats.org/officeDocument/2006/relationships/image" Target="../media/image2.tiff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 descr="民衆, テーブル, 女性, グループ が含まれている画像&#10;&#10;自動的に生成された説明">
            <a:extLst>
              <a:ext uri="{FF2B5EF4-FFF2-40B4-BE49-F238E27FC236}">
                <a16:creationId xmlns:a16="http://schemas.microsoft.com/office/drawing/2014/main" id="{8C265056-F32D-3AA7-1951-4ED3C65317FF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V="1">
            <a:off x="2514587" y="7730693"/>
            <a:ext cx="1797518" cy="13535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図 6" descr="紫, 座る, 閉じる, 色付け が含まれている画像&#10;&#10;自動的に生成された説明">
            <a:extLst>
              <a:ext uri="{FF2B5EF4-FFF2-40B4-BE49-F238E27FC236}">
                <a16:creationId xmlns:a16="http://schemas.microsoft.com/office/drawing/2014/main" id="{7DE9D8A8-BE98-A329-FEEC-66736E6DA2D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37496" y="7729057"/>
            <a:ext cx="1800000" cy="135686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5DD8B82C-0348-4907-6CD2-4020129C4A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7662321"/>
              </p:ext>
            </p:extLst>
          </p:nvPr>
        </p:nvGraphicFramePr>
        <p:xfrm>
          <a:off x="633462" y="806452"/>
          <a:ext cx="5242467" cy="2582152"/>
        </p:xfrm>
        <a:graphic>
          <a:graphicData uri="http://schemas.openxmlformats.org/drawingml/2006/table">
            <a:tbl>
              <a:tblPr/>
              <a:tblGrid>
                <a:gridCol w="1545300">
                  <a:extLst>
                    <a:ext uri="{9D8B030D-6E8A-4147-A177-3AD203B41FA5}">
                      <a16:colId xmlns:a16="http://schemas.microsoft.com/office/drawing/2014/main" val="366260727"/>
                    </a:ext>
                  </a:extLst>
                </a:gridCol>
                <a:gridCol w="3697167">
                  <a:extLst>
                    <a:ext uri="{9D8B030D-6E8A-4147-A177-3AD203B41FA5}">
                      <a16:colId xmlns:a16="http://schemas.microsoft.com/office/drawing/2014/main" val="1530164657"/>
                    </a:ext>
                  </a:extLst>
                </a:gridCol>
              </a:tblGrid>
              <a:tr h="226697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1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ja-JP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Name</a:t>
                      </a:r>
                      <a:endParaRPr lang="ja-JP" altLang="en-US" sz="1100" b="1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Sequence 5’ → 3’ (PAM sequences are underlined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8854799"/>
                  </a:ext>
                </a:extLst>
              </a:tr>
              <a:tr h="2121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RNA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taccgtcccaagagaacctg</a:t>
                      </a:r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a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9725204"/>
                  </a:ext>
                </a:extLst>
              </a:tr>
              <a:tr h="2094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RNA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tccatggagcaggaataaag</a:t>
                      </a:r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a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3946470"/>
                  </a:ext>
                </a:extLst>
              </a:tr>
              <a:tr h="2045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RNA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acccgccagcagtgtgagt</a:t>
                      </a:r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gg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1169977"/>
                  </a:ext>
                </a:extLst>
              </a:tr>
              <a:tr h="8646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dr_ssDNA</a:t>
                      </a:r>
                    </a:p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mutation-1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taggctacagcagccatcacctttataaaaacccaagccatatttgaattgtctttaaatttcaaggaagaggacaaagaaatgtgagcaaggcttcattcctagctctcagactaccgtcccaagagacggcgggtctgaagtgcggttggccccaacactcctcccaaagtatctatcaagagaatggtcagcagaagttagatctaggtaagaggacgggaagggggactagtcttgggaaagcgccacatttcctggt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959313"/>
                  </a:ext>
                </a:extLst>
              </a:tr>
              <a:tr h="86468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dr_ssDNA</a:t>
                      </a:r>
                    </a:p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(mutation-2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ＭＳ Ｐゴシック" panose="020B0600070205080204" pitchFamily="34" charset="-128"/>
                          <a:cs typeface="Arial" panose="020B0604020202020204" pitchFamily="34" charset="0"/>
                        </a:rPr>
                        <a:t>taggctacagcagccatcacctttataaaaacccaagccatatttgaattgtctttaaatttcaaggaagaggacaaagaaatggcgggtctgaagtgcggttggccccaacactcctcccaaagtatctatcaagagaatggtcagcagaagttagatctaggtaagaggacgggaagggggactagtcttgggaaagcgccacatttcctggt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69311625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5AB645D-9E00-E422-7701-859CD0B5DB15}"/>
              </a:ext>
            </a:extLst>
          </p:cNvPr>
          <p:cNvSpPr txBox="1"/>
          <p:nvPr/>
        </p:nvSpPr>
        <p:spPr>
          <a:xfrm>
            <a:off x="215516" y="502641"/>
            <a:ext cx="503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図 10" descr="雪, 食品, 覆い, コーヒー が含まれている画像&#10;&#10;自動的に生成された説明">
            <a:extLst>
              <a:ext uri="{FF2B5EF4-FFF2-40B4-BE49-F238E27FC236}">
                <a16:creationId xmlns:a16="http://schemas.microsoft.com/office/drawing/2014/main" id="{FF0EF4B9-ABFF-6209-4568-ECFF47AC5422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46488" y="6209933"/>
            <a:ext cx="1271821" cy="9576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973C27F-29A7-6561-99AE-14C965A4CBF0}"/>
              </a:ext>
            </a:extLst>
          </p:cNvPr>
          <p:cNvSpPr txBox="1"/>
          <p:nvPr/>
        </p:nvSpPr>
        <p:spPr>
          <a:xfrm>
            <a:off x="893559" y="5898331"/>
            <a:ext cx="7374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CF8F6BC-2E1E-3004-A6B7-44EECC75139E}"/>
              </a:ext>
            </a:extLst>
          </p:cNvPr>
          <p:cNvSpPr txBox="1"/>
          <p:nvPr/>
        </p:nvSpPr>
        <p:spPr>
          <a:xfrm>
            <a:off x="2052819" y="5899426"/>
            <a:ext cx="1100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r>
              <a:rPr lang="en-US" altLang="ja-JP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dr/Δdr</a:t>
            </a:r>
            <a:endParaRPr lang="ja-JP" altLang="en-US" sz="1200" b="1" i="1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27A368B4-2237-4B8E-6EE9-D8E640349161}"/>
              </a:ext>
            </a:extLst>
          </p:cNvPr>
          <p:cNvCxnSpPr>
            <a:cxnSpLocks/>
          </p:cNvCxnSpPr>
          <p:nvPr/>
        </p:nvCxnSpPr>
        <p:spPr>
          <a:xfrm>
            <a:off x="546377" y="6213558"/>
            <a:ext cx="0" cy="9576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0A98B6E-73E4-A1A2-D5EE-6F2A17F32646}"/>
              </a:ext>
            </a:extLst>
          </p:cNvPr>
          <p:cNvSpPr txBox="1"/>
          <p:nvPr/>
        </p:nvSpPr>
        <p:spPr>
          <a:xfrm rot="16200000">
            <a:off x="77551" y="6563693"/>
            <a:ext cx="736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</a:p>
        </p:txBody>
      </p: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32E1BC8F-D9FB-A8D1-FEF5-1FD2E0F9749B}"/>
              </a:ext>
            </a:extLst>
          </p:cNvPr>
          <p:cNvCxnSpPr>
            <a:cxnSpLocks/>
          </p:cNvCxnSpPr>
          <p:nvPr/>
        </p:nvCxnSpPr>
        <p:spPr>
          <a:xfrm>
            <a:off x="621674" y="6141220"/>
            <a:ext cx="127164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0EA07397-E70A-29A2-1888-42EBAAB7A435}"/>
              </a:ext>
            </a:extLst>
          </p:cNvPr>
          <p:cNvCxnSpPr>
            <a:cxnSpLocks/>
          </p:cNvCxnSpPr>
          <p:nvPr/>
        </p:nvCxnSpPr>
        <p:spPr>
          <a:xfrm>
            <a:off x="1971889" y="6142487"/>
            <a:ext cx="127046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9E679E88-F171-536B-D8AA-320761EF6692}"/>
              </a:ext>
            </a:extLst>
          </p:cNvPr>
          <p:cNvCxnSpPr>
            <a:cxnSpLocks/>
          </p:cNvCxnSpPr>
          <p:nvPr/>
        </p:nvCxnSpPr>
        <p:spPr>
          <a:xfrm>
            <a:off x="3888594" y="6144306"/>
            <a:ext cx="126824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875320F9-EE25-D588-76FC-CF6AE2067E0A}"/>
              </a:ext>
            </a:extLst>
          </p:cNvPr>
          <p:cNvCxnSpPr>
            <a:cxnSpLocks/>
          </p:cNvCxnSpPr>
          <p:nvPr/>
        </p:nvCxnSpPr>
        <p:spPr>
          <a:xfrm>
            <a:off x="5240394" y="6139548"/>
            <a:ext cx="126824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4B9D74B8-DF06-425D-3E52-D3CCD5C0D046}"/>
              </a:ext>
            </a:extLst>
          </p:cNvPr>
          <p:cNvCxnSpPr>
            <a:cxnSpLocks/>
          </p:cNvCxnSpPr>
          <p:nvPr/>
        </p:nvCxnSpPr>
        <p:spPr>
          <a:xfrm>
            <a:off x="621674" y="5904155"/>
            <a:ext cx="262449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A47B84C-2154-C1DF-DBB9-9A64440DA6BC}"/>
              </a:ext>
            </a:extLst>
          </p:cNvPr>
          <p:cNvSpPr txBox="1"/>
          <p:nvPr/>
        </p:nvSpPr>
        <p:spPr>
          <a:xfrm>
            <a:off x="1279134" y="5669340"/>
            <a:ext cx="1339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Rete testis (8w)</a:t>
            </a:r>
          </a:p>
        </p:txBody>
      </p: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75FA5788-5FAA-9EA7-55C7-EE9F47A909FC}"/>
              </a:ext>
            </a:extLst>
          </p:cNvPr>
          <p:cNvCxnSpPr>
            <a:cxnSpLocks/>
          </p:cNvCxnSpPr>
          <p:nvPr/>
        </p:nvCxnSpPr>
        <p:spPr>
          <a:xfrm>
            <a:off x="3888761" y="5905766"/>
            <a:ext cx="262449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4C7445A0-0547-05F6-6C27-1A78DBC21F9E}"/>
              </a:ext>
            </a:extLst>
          </p:cNvPr>
          <p:cNvSpPr txBox="1"/>
          <p:nvPr/>
        </p:nvSpPr>
        <p:spPr>
          <a:xfrm>
            <a:off x="4521835" y="5665398"/>
            <a:ext cx="1268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Uterus (3w)</a:t>
            </a: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F9A2E052-E920-809E-CAC7-5032E5962BAC}"/>
              </a:ext>
            </a:extLst>
          </p:cNvPr>
          <p:cNvSpPr txBox="1"/>
          <p:nvPr/>
        </p:nvSpPr>
        <p:spPr>
          <a:xfrm>
            <a:off x="4153635" y="5905310"/>
            <a:ext cx="7374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4FF78D6-5D5A-B06E-9047-78AFDD514DA4}"/>
              </a:ext>
            </a:extLst>
          </p:cNvPr>
          <p:cNvSpPr txBox="1"/>
          <p:nvPr/>
        </p:nvSpPr>
        <p:spPr>
          <a:xfrm>
            <a:off x="5312132" y="5899294"/>
            <a:ext cx="1100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  <a:r>
              <a:rPr lang="en-US" altLang="ja-JP" sz="12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Δdr/Δdr</a:t>
            </a:r>
            <a:endParaRPr lang="ja-JP" altLang="en-US" sz="1200" b="1" i="1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492506FF-B594-D5D1-D951-9EB2CBB6F2DF}"/>
              </a:ext>
            </a:extLst>
          </p:cNvPr>
          <p:cNvSpPr txBox="1"/>
          <p:nvPr/>
        </p:nvSpPr>
        <p:spPr>
          <a:xfrm>
            <a:off x="215516" y="5612062"/>
            <a:ext cx="503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 descr="屋外, 男, ウォーキング, 雪 が含まれている画像&#10;&#10;自動的に生成された説明">
            <a:extLst>
              <a:ext uri="{FF2B5EF4-FFF2-40B4-BE49-F238E27FC236}">
                <a16:creationId xmlns:a16="http://schemas.microsoft.com/office/drawing/2014/main" id="{ED8ECF27-FAB7-1E56-DDB0-87D2C16F6738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894682" y="6209939"/>
            <a:ext cx="1271821" cy="957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4ED1CBD-7264-41DF-F518-157D1F70886F}"/>
              </a:ext>
            </a:extLst>
          </p:cNvPr>
          <p:cNvSpPr txBox="1"/>
          <p:nvPr/>
        </p:nvSpPr>
        <p:spPr>
          <a:xfrm>
            <a:off x="4249517" y="6488684"/>
            <a:ext cx="3265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le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A139F18D-F6BA-FC82-85E5-0C845C6DBAE8}"/>
              </a:ext>
            </a:extLst>
          </p:cNvPr>
          <p:cNvSpPr txBox="1"/>
          <p:nvPr/>
        </p:nvSpPr>
        <p:spPr>
          <a:xfrm>
            <a:off x="4471512" y="6862754"/>
            <a:ext cx="3265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ge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図 21" descr="雪が積もった地面&#10;&#10;自動的に生成された説明">
            <a:extLst>
              <a:ext uri="{FF2B5EF4-FFF2-40B4-BE49-F238E27FC236}">
                <a16:creationId xmlns:a16="http://schemas.microsoft.com/office/drawing/2014/main" id="{3EFF6663-BAA5-07C9-9FC5-FA0E33289AF5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18360" y="6209939"/>
            <a:ext cx="1271821" cy="957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5C202DC-6DDB-EFF8-EB20-2FA209E6DA5C}"/>
              </a:ext>
            </a:extLst>
          </p:cNvPr>
          <p:cNvSpPr txBox="1"/>
          <p:nvPr/>
        </p:nvSpPr>
        <p:spPr>
          <a:xfrm>
            <a:off x="1255101" y="6523335"/>
            <a:ext cx="3265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図 23" descr="雪が積もった地面&#10;&#10;自動的に生成された説明">
            <a:extLst>
              <a:ext uri="{FF2B5EF4-FFF2-40B4-BE49-F238E27FC236}">
                <a16:creationId xmlns:a16="http://schemas.microsoft.com/office/drawing/2014/main" id="{5A84C3C4-4E08-0BA8-F83A-81CFD810EEFE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70541" y="6209939"/>
            <a:ext cx="1271812" cy="957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5A2E16B-2251-ADE3-A579-65C9ACF5FDF8}"/>
              </a:ext>
            </a:extLst>
          </p:cNvPr>
          <p:cNvSpPr txBox="1"/>
          <p:nvPr/>
        </p:nvSpPr>
        <p:spPr>
          <a:xfrm>
            <a:off x="2521231" y="6584796"/>
            <a:ext cx="3265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rt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9FE1CB1-8C72-61CE-2593-9323A4A02FCA}"/>
              </a:ext>
            </a:extLst>
          </p:cNvPr>
          <p:cNvSpPr txBox="1"/>
          <p:nvPr/>
        </p:nvSpPr>
        <p:spPr>
          <a:xfrm>
            <a:off x="212672" y="7354208"/>
            <a:ext cx="503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7BA58E5-3879-FEEE-BC7C-04CFB2815A56}"/>
              </a:ext>
            </a:extLst>
          </p:cNvPr>
          <p:cNvSpPr txBox="1"/>
          <p:nvPr/>
        </p:nvSpPr>
        <p:spPr>
          <a:xfrm>
            <a:off x="843841" y="7404895"/>
            <a:ext cx="13783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ja-JP" sz="1200" b="1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BA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ja-JP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X9</a:t>
            </a: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08B074B0-6492-C7FE-5488-91CA209B6BF5}"/>
              </a:ext>
            </a:extLst>
          </p:cNvPr>
          <p:cNvCxnSpPr>
            <a:cxnSpLocks/>
          </p:cNvCxnSpPr>
          <p:nvPr/>
        </p:nvCxnSpPr>
        <p:spPr>
          <a:xfrm>
            <a:off x="2513346" y="7652457"/>
            <a:ext cx="180000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8960453-4D72-216A-5841-B2676A4B08B2}"/>
              </a:ext>
            </a:extLst>
          </p:cNvPr>
          <p:cNvSpPr txBox="1"/>
          <p:nvPr/>
        </p:nvSpPr>
        <p:spPr>
          <a:xfrm>
            <a:off x="2727078" y="7402722"/>
            <a:ext cx="12025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B-PAS</a:t>
            </a: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CF1D42E5-10D1-569D-2D41-78544A38862C}"/>
              </a:ext>
            </a:extLst>
          </p:cNvPr>
          <p:cNvCxnSpPr>
            <a:cxnSpLocks/>
          </p:cNvCxnSpPr>
          <p:nvPr/>
        </p:nvCxnSpPr>
        <p:spPr>
          <a:xfrm>
            <a:off x="633462" y="7652457"/>
            <a:ext cx="180000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985C362-4918-720C-4F8F-E3D7B221D6D3}"/>
              </a:ext>
            </a:extLst>
          </p:cNvPr>
          <p:cNvSpPr txBox="1"/>
          <p:nvPr/>
        </p:nvSpPr>
        <p:spPr>
          <a:xfrm rot="16200000">
            <a:off x="32956" y="8259998"/>
            <a:ext cx="814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D31D7715-D9A7-3332-4DDB-27E7574C1B52}"/>
              </a:ext>
            </a:extLst>
          </p:cNvPr>
          <p:cNvCxnSpPr/>
          <p:nvPr/>
        </p:nvCxnSpPr>
        <p:spPr>
          <a:xfrm>
            <a:off x="554799" y="7737517"/>
            <a:ext cx="0" cy="13536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D73825A-C05C-AF58-B824-E0A5C3BBA2EE}"/>
              </a:ext>
            </a:extLst>
          </p:cNvPr>
          <p:cNvSpPr txBox="1"/>
          <p:nvPr/>
        </p:nvSpPr>
        <p:spPr>
          <a:xfrm>
            <a:off x="1803341" y="8006553"/>
            <a:ext cx="399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bd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E90AAE0-EB35-7097-E0BA-E0243DD918DD}"/>
              </a:ext>
            </a:extLst>
          </p:cNvPr>
          <p:cNvSpPr txBox="1"/>
          <p:nvPr/>
        </p:nvSpPr>
        <p:spPr>
          <a:xfrm>
            <a:off x="1265907" y="8114275"/>
            <a:ext cx="399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uo</a:t>
            </a:r>
            <a:endParaRPr kumimoji="1" lang="ja-JP" altLang="en-US" sz="8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5A741E5-86B7-BCBF-E3CA-68EF94899D65}"/>
              </a:ext>
            </a:extLst>
          </p:cNvPr>
          <p:cNvSpPr txBox="1"/>
          <p:nvPr/>
        </p:nvSpPr>
        <p:spPr>
          <a:xfrm>
            <a:off x="3522354" y="5612129"/>
            <a:ext cx="503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D1AE723D-518F-4A16-3B6A-D4378D45F0C4}"/>
              </a:ext>
            </a:extLst>
          </p:cNvPr>
          <p:cNvCxnSpPr>
            <a:cxnSpLocks/>
          </p:cNvCxnSpPr>
          <p:nvPr/>
        </p:nvCxnSpPr>
        <p:spPr>
          <a:xfrm>
            <a:off x="3822482" y="6213558"/>
            <a:ext cx="0" cy="9576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4CD9360-297F-9548-E8F4-AD72782AF7B1}"/>
              </a:ext>
            </a:extLst>
          </p:cNvPr>
          <p:cNvSpPr txBox="1"/>
          <p:nvPr/>
        </p:nvSpPr>
        <p:spPr>
          <a:xfrm rot="16200000">
            <a:off x="3360429" y="6563693"/>
            <a:ext cx="736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OX17</a:t>
            </a:r>
          </a:p>
        </p:txBody>
      </p:sp>
      <p:pic>
        <p:nvPicPr>
          <p:cNvPr id="8" name="図 7" descr="テーブル, 皿, 食品, 座る が含まれている画像&#10;&#10;自動的に生成された説明">
            <a:extLst>
              <a:ext uri="{FF2B5EF4-FFF2-40B4-BE49-F238E27FC236}">
                <a16:creationId xmlns:a16="http://schemas.microsoft.com/office/drawing/2014/main" id="{C7F2AEE0-F586-9B6E-3263-78EFAF49371A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18360" y="6811594"/>
            <a:ext cx="383127" cy="3559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DA347025-17C0-675E-8664-DB518B695C63}"/>
              </a:ext>
            </a:extLst>
          </p:cNvPr>
          <p:cNvSpPr>
            <a:spLocks noChangeAspect="1"/>
          </p:cNvSpPr>
          <p:nvPr/>
        </p:nvSpPr>
        <p:spPr>
          <a:xfrm>
            <a:off x="1359057" y="6346907"/>
            <a:ext cx="72000" cy="72000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>
              <a:noFill/>
            </a:endParaRPr>
          </a:p>
        </p:txBody>
      </p:sp>
      <p:pic>
        <p:nvPicPr>
          <p:cNvPr id="14" name="図 13" descr="雪が積もった地面&#10;&#10;中程度の精度で自動的に生成された説明">
            <a:extLst>
              <a:ext uri="{FF2B5EF4-FFF2-40B4-BE49-F238E27FC236}">
                <a16:creationId xmlns:a16="http://schemas.microsoft.com/office/drawing/2014/main" id="{4FCBAB30-AE9A-4CF3-B421-D3D92EE7362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70166" y="6812173"/>
            <a:ext cx="383127" cy="3553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E8343255-E010-13DB-66DF-26DBF1BDB9DE}"/>
              </a:ext>
            </a:extLst>
          </p:cNvPr>
          <p:cNvSpPr>
            <a:spLocks noChangeAspect="1"/>
          </p:cNvSpPr>
          <p:nvPr/>
        </p:nvSpPr>
        <p:spPr>
          <a:xfrm>
            <a:off x="2460934" y="6655911"/>
            <a:ext cx="72000" cy="72000"/>
          </a:xfrm>
          <a:prstGeom prst="rect">
            <a:avLst/>
          </a:prstGeom>
          <a:noFill/>
          <a:ln w="12700"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>
              <a:noFill/>
            </a:endParaRPr>
          </a:p>
        </p:txBody>
      </p:sp>
      <p:pic>
        <p:nvPicPr>
          <p:cNvPr id="29" name="図 28" descr="ダイアグラム, 概略図&#10;&#10;自動的に生成された説明">
            <a:extLst>
              <a:ext uri="{FF2B5EF4-FFF2-40B4-BE49-F238E27FC236}">
                <a16:creationId xmlns:a16="http://schemas.microsoft.com/office/drawing/2014/main" id="{529430E5-057C-5874-E84A-26C00F65B74C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56916" y="3557644"/>
            <a:ext cx="3316706" cy="1987629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329A459-7823-A596-977D-ED9BB8DCCE08}"/>
              </a:ext>
            </a:extLst>
          </p:cNvPr>
          <p:cNvSpPr txBox="1"/>
          <p:nvPr/>
        </p:nvSpPr>
        <p:spPr>
          <a:xfrm>
            <a:off x="217984" y="3507640"/>
            <a:ext cx="5479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ECC05116-12B8-A3E6-1BE1-D91814EF17BD}"/>
              </a:ext>
            </a:extLst>
          </p:cNvPr>
          <p:cNvGrpSpPr/>
          <p:nvPr/>
        </p:nvGrpSpPr>
        <p:grpSpPr>
          <a:xfrm>
            <a:off x="3839671" y="3785480"/>
            <a:ext cx="2519130" cy="1624068"/>
            <a:chOff x="3875321" y="5657411"/>
            <a:chExt cx="2519130" cy="1624068"/>
          </a:xfrm>
        </p:grpSpPr>
        <p:grpSp>
          <p:nvGrpSpPr>
            <p:cNvPr id="44" name="グループ化 43">
              <a:extLst>
                <a:ext uri="{FF2B5EF4-FFF2-40B4-BE49-F238E27FC236}">
                  <a16:creationId xmlns:a16="http://schemas.microsoft.com/office/drawing/2014/main" id="{F8B59413-819A-241F-58A4-FFA04B86E7DC}"/>
                </a:ext>
              </a:extLst>
            </p:cNvPr>
            <p:cNvGrpSpPr/>
            <p:nvPr/>
          </p:nvGrpSpPr>
          <p:grpSpPr>
            <a:xfrm>
              <a:off x="3875321" y="5886945"/>
              <a:ext cx="2519130" cy="1394534"/>
              <a:chOff x="3889071" y="5886945"/>
              <a:chExt cx="2519130" cy="1394534"/>
            </a:xfrm>
          </p:grpSpPr>
          <p:pic>
            <p:nvPicPr>
              <p:cNvPr id="53" name="図 52" descr="グラフ, ヒストグラム&#10;&#10;自動的に生成された説明">
                <a:extLst>
                  <a:ext uri="{FF2B5EF4-FFF2-40B4-BE49-F238E27FC236}">
                    <a16:creationId xmlns:a16="http://schemas.microsoft.com/office/drawing/2014/main" id="{81D101F2-D4E1-2B02-6283-C78E4D0E2C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89071" y="5902443"/>
                <a:ext cx="142495" cy="1379036"/>
              </a:xfrm>
              <a:prstGeom prst="rect">
                <a:avLst/>
              </a:prstGeom>
            </p:spPr>
          </p:pic>
          <p:pic>
            <p:nvPicPr>
              <p:cNvPr id="54" name="図 53" descr="グラフ, ヒストグラム&#10;&#10;自動的に生成された説明">
                <a:extLst>
                  <a:ext uri="{FF2B5EF4-FFF2-40B4-BE49-F238E27FC236}">
                    <a16:creationId xmlns:a16="http://schemas.microsoft.com/office/drawing/2014/main" id="{9D7D163A-2085-D13B-5CD5-7C5A94E182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006851" y="5886945"/>
                <a:ext cx="2401350" cy="1379036"/>
              </a:xfrm>
              <a:prstGeom prst="rect">
                <a:avLst/>
              </a:prstGeom>
            </p:spPr>
          </p:pic>
        </p:grp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50D8BC37-5208-9848-0F85-7D2EB26BC806}"/>
                </a:ext>
              </a:extLst>
            </p:cNvPr>
            <p:cNvCxnSpPr>
              <a:cxnSpLocks/>
            </p:cNvCxnSpPr>
            <p:nvPr/>
          </p:nvCxnSpPr>
          <p:spPr>
            <a:xfrm>
              <a:off x="4879801" y="5905618"/>
              <a:ext cx="0" cy="1238400"/>
            </a:xfrm>
            <a:prstGeom prst="line">
              <a:avLst/>
            </a:prstGeom>
            <a:ln w="6350">
              <a:solidFill>
                <a:srgbClr val="393939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3066259B-A43E-08E9-B605-A59255CFAE88}"/>
                </a:ext>
              </a:extLst>
            </p:cNvPr>
            <p:cNvCxnSpPr>
              <a:cxnSpLocks/>
            </p:cNvCxnSpPr>
            <p:nvPr/>
          </p:nvCxnSpPr>
          <p:spPr>
            <a:xfrm>
              <a:off x="5502746" y="5905618"/>
              <a:ext cx="0" cy="1238400"/>
            </a:xfrm>
            <a:prstGeom prst="line">
              <a:avLst/>
            </a:prstGeom>
            <a:ln w="6350">
              <a:solidFill>
                <a:srgbClr val="393939"/>
              </a:solidFill>
              <a:prstDash val="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A50C2349-913B-91F0-CF68-184DBF0A70ED}"/>
                </a:ext>
              </a:extLst>
            </p:cNvPr>
            <p:cNvSpPr txBox="1"/>
            <p:nvPr/>
          </p:nvSpPr>
          <p:spPr>
            <a:xfrm>
              <a:off x="4106298" y="5657411"/>
              <a:ext cx="8614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target α</a:t>
              </a:r>
              <a:endParaRPr kumimoji="1" lang="ja-JP" altLang="en-US" sz="1200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97D5EDD-1BF1-BE32-BD92-DCD3730981B1}"/>
                </a:ext>
              </a:extLst>
            </p:cNvPr>
            <p:cNvSpPr txBox="1"/>
            <p:nvPr/>
          </p:nvSpPr>
          <p:spPr>
            <a:xfrm>
              <a:off x="4820413" y="5657986"/>
              <a:ext cx="7359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target β</a:t>
              </a:r>
              <a:endParaRPr kumimoji="1" lang="ja-JP" altLang="en-US" sz="1200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B565F532-E6E8-1E26-4F90-A74BCBFE1CB1}"/>
                </a:ext>
              </a:extLst>
            </p:cNvPr>
            <p:cNvSpPr txBox="1"/>
            <p:nvPr/>
          </p:nvSpPr>
          <p:spPr>
            <a:xfrm>
              <a:off x="5471180" y="5657661"/>
              <a:ext cx="751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target γ</a:t>
              </a:r>
              <a:endParaRPr kumimoji="1" lang="ja-JP" altLang="en-US" sz="1200"/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03B1E3E-6929-5A49-B231-1E17FF357D69}"/>
              </a:ext>
            </a:extLst>
          </p:cNvPr>
          <p:cNvSpPr txBox="1"/>
          <p:nvPr/>
        </p:nvSpPr>
        <p:spPr>
          <a:xfrm>
            <a:off x="0" y="3265"/>
            <a:ext cx="39553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2</a:t>
            </a:r>
            <a:endParaRPr kumimoji="1" lang="ja-JP" altLang="en-US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2AE93090-9CE6-7EA3-FD06-D08F387898CD}"/>
              </a:ext>
            </a:extLst>
          </p:cNvPr>
          <p:cNvGrpSpPr/>
          <p:nvPr/>
        </p:nvGrpSpPr>
        <p:grpSpPr>
          <a:xfrm>
            <a:off x="3784774" y="3594832"/>
            <a:ext cx="3300524" cy="1944689"/>
            <a:chOff x="3784774" y="3608582"/>
            <a:chExt cx="3300524" cy="1944689"/>
          </a:xfrm>
        </p:grpSpPr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F5D633DB-C246-DFBA-556F-CBD566D0C344}"/>
                </a:ext>
              </a:extLst>
            </p:cNvPr>
            <p:cNvSpPr txBox="1"/>
            <p:nvPr/>
          </p:nvSpPr>
          <p:spPr>
            <a:xfrm>
              <a:off x="4067237" y="3608582"/>
              <a:ext cx="8614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target α</a:t>
              </a:r>
              <a:endParaRPr kumimoji="1" lang="ja-JP" altLang="en-US" sz="1200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6ED075F7-9B3D-35FF-9A47-0D7C9B8FE295}"/>
                </a:ext>
              </a:extLst>
            </p:cNvPr>
            <p:cNvSpPr txBox="1"/>
            <p:nvPr/>
          </p:nvSpPr>
          <p:spPr>
            <a:xfrm>
              <a:off x="4770015" y="3609157"/>
              <a:ext cx="7359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target β</a:t>
              </a:r>
              <a:endParaRPr kumimoji="1" lang="ja-JP" altLang="en-US" sz="1200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77165F34-4298-A79A-26FA-DF75C306262F}"/>
                </a:ext>
              </a:extLst>
            </p:cNvPr>
            <p:cNvSpPr txBox="1"/>
            <p:nvPr/>
          </p:nvSpPr>
          <p:spPr>
            <a:xfrm>
              <a:off x="5401887" y="3608832"/>
              <a:ext cx="7516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target γ</a:t>
              </a:r>
              <a:endParaRPr kumimoji="1" lang="ja-JP" altLang="en-US" sz="1200"/>
            </a:p>
          </p:txBody>
        </p:sp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3DE2A5ED-F968-51A6-5C20-631E8E0939A2}"/>
                </a:ext>
              </a:extLst>
            </p:cNvPr>
            <p:cNvGrpSpPr/>
            <p:nvPr/>
          </p:nvGrpSpPr>
          <p:grpSpPr>
            <a:xfrm>
              <a:off x="3784774" y="3870210"/>
              <a:ext cx="2581102" cy="1683061"/>
              <a:chOff x="3887540" y="4475900"/>
              <a:chExt cx="2581102" cy="1683061"/>
            </a:xfrm>
          </p:grpSpPr>
          <p:pic>
            <p:nvPicPr>
              <p:cNvPr id="28" name="図 27" descr="グラフ&#10;&#10;自動的に生成された説明">
                <a:extLst>
                  <a:ext uri="{FF2B5EF4-FFF2-40B4-BE49-F238E27FC236}">
                    <a16:creationId xmlns:a16="http://schemas.microsoft.com/office/drawing/2014/main" id="{4F215689-2768-F717-1125-6B351B55B7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87540" y="4475900"/>
                <a:ext cx="2581102" cy="1683061"/>
              </a:xfrm>
              <a:prstGeom prst="rect">
                <a:avLst/>
              </a:prstGeom>
            </p:spPr>
          </p:pic>
          <p:cxnSp>
            <p:nvCxnSpPr>
              <p:cNvPr id="31" name="直線コネクタ 30">
                <a:extLst>
                  <a:ext uri="{FF2B5EF4-FFF2-40B4-BE49-F238E27FC236}">
                    <a16:creationId xmlns:a16="http://schemas.microsoft.com/office/drawing/2014/main" id="{99544CCE-0144-147B-740D-B97BA23B93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33885" y="4490288"/>
                <a:ext cx="0" cy="1537200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線コネクタ 54">
                <a:extLst>
                  <a:ext uri="{FF2B5EF4-FFF2-40B4-BE49-F238E27FC236}">
                    <a16:creationId xmlns:a16="http://schemas.microsoft.com/office/drawing/2014/main" id="{62493085-BFA8-E156-CC64-C0B392A6FD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46484" y="4490288"/>
                <a:ext cx="0" cy="1537200"/>
              </a:xfrm>
              <a:prstGeom prst="line">
                <a:avLst/>
              </a:prstGeom>
              <a:ln w="6350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A644A26F-F428-EADC-179C-EEF09E6A33A0}"/>
                </a:ext>
              </a:extLst>
            </p:cNvPr>
            <p:cNvSpPr txBox="1"/>
            <p:nvPr/>
          </p:nvSpPr>
          <p:spPr>
            <a:xfrm>
              <a:off x="6283615" y="4647713"/>
              <a:ext cx="80168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500" i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x17</a:t>
              </a:r>
              <a:r>
                <a:rPr kumimoji="1" lang="en-US" altLang="ja-JP" sz="500" i="1" baseline="30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dr/Δdr</a:t>
              </a:r>
              <a:endParaRPr kumimoji="1" lang="ja-JP" altLang="en-US" sz="500" i="1" baseline="30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2C6BFEF4-4B85-A646-90D5-F9ED3AFF0340}"/>
                </a:ext>
              </a:extLst>
            </p:cNvPr>
            <p:cNvSpPr txBox="1"/>
            <p:nvPr/>
          </p:nvSpPr>
          <p:spPr>
            <a:xfrm>
              <a:off x="6283615" y="4527882"/>
              <a:ext cx="80168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500" baseline="30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76716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725</TotalTime>
  <Words>92</Words>
  <Application>Microsoft Macintosh PowerPoint</Application>
  <PresentationFormat>A4 210 x 297 mm</PresentationFormat>
  <Paragraphs>4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曽　詩涵</dc:creator>
  <cp:lastModifiedBy>Ayaka Yanagida</cp:lastModifiedBy>
  <cp:revision>290</cp:revision>
  <cp:lastPrinted>2024-05-27T07:08:29Z</cp:lastPrinted>
  <dcterms:created xsi:type="dcterms:W3CDTF">2024-05-27T07:05:45Z</dcterms:created>
  <dcterms:modified xsi:type="dcterms:W3CDTF">2024-12-16T15:53:39Z</dcterms:modified>
</cp:coreProperties>
</file>